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FC0D9-329A-4F85-970A-318155BEE8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C2F3FA-D43F-4513-9EB1-0918D4A99D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AB75E-9D50-4510-913F-BA477AE95D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49E4C-7B54-49C8-B7FD-246D4DBC5A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87890-30D0-41F6-8BAB-FAB790C8E2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01C71A-2E0C-4858-84EE-50818749983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E27EA-94C6-41C8-980B-83CE3042EE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F6680-A528-4B05-81D3-AFF5701B99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986BF-F114-4DD1-B6E7-E168E3745E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2F245-C5DA-4C25-9017-BAA6CDAD5D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6CE99-D2D2-46D3-B8FB-47E65D9BE3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96F52-681F-401C-9A93-CF7519CCBE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A950D9-16B7-427E-9947-C62E6D69C7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39080" y="314280"/>
            <a:ext cx="41706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                                          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868320" y="712440"/>
            <a:ext cx="6992640" cy="1872720"/>
            <a:chOff x="868320" y="712440"/>
            <a:chExt cx="6992640" cy="1872720"/>
          </a:xfrm>
        </p:grpSpPr>
        <p:sp>
          <p:nvSpPr>
            <p:cNvPr id="43" name=""/>
            <p:cNvSpPr/>
            <p:nvPr/>
          </p:nvSpPr>
          <p:spPr>
            <a:xfrm>
              <a:off x="4608360" y="1405080"/>
              <a:ext cx="552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kD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631400" y="1774800"/>
              <a:ext cx="47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36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650480" y="2247840"/>
              <a:ext cx="473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50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6688080" y="2195640"/>
              <a:ext cx="1172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-</a:t>
              </a:r>
              <a:r>
                <a:rPr b="1" lang="en-US" sz="16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-Tubuli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688800" y="1755720"/>
              <a:ext cx="50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-T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9811400">
              <a:off x="5197680" y="1123560"/>
              <a:ext cx="174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negative control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9965000">
              <a:off x="6131160" y="1415520"/>
              <a:ext cx="609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SimSun"/>
                </a:rPr>
                <a:t>siT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0" name=""/>
            <p:cNvGraphicFramePr/>
            <p:nvPr/>
          </p:nvGraphicFramePr>
          <p:xfrm>
            <a:off x="5105520" y="2247840"/>
            <a:ext cx="1600200" cy="3175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5105520" y="2247840"/>
                      <a:ext cx="1600200" cy="31752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52" name=""/>
            <p:cNvGraphicFramePr/>
            <p:nvPr/>
          </p:nvGraphicFramePr>
          <p:xfrm>
            <a:off x="5105520" y="1790640"/>
            <a:ext cx="1600200" cy="30492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3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105520" y="1790640"/>
                      <a:ext cx="1600200" cy="304920"/>
                    </a:xfrm>
                    <a:prstGeom prst="rect">
                      <a:avLst/>
                    </a:prstGeom>
                    <a:ln w="648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pSp>
          <p:nvGrpSpPr>
            <p:cNvPr id="54" name=""/>
            <p:cNvGrpSpPr/>
            <p:nvPr/>
          </p:nvGrpSpPr>
          <p:grpSpPr>
            <a:xfrm>
              <a:off x="868320" y="718560"/>
              <a:ext cx="3309840" cy="1857600"/>
              <a:chOff x="868320" y="718560"/>
              <a:chExt cx="3309840" cy="1857600"/>
            </a:xfrm>
          </p:grpSpPr>
          <p:sp>
            <p:nvSpPr>
              <p:cNvPr id="55" name=""/>
              <p:cNvSpPr/>
              <p:nvPr/>
            </p:nvSpPr>
            <p:spPr>
              <a:xfrm>
                <a:off x="868320" y="1381320"/>
                <a:ext cx="5526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kDa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884880" y="1735560"/>
                <a:ext cx="473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21-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888120" y="2219760"/>
                <a:ext cx="4734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50-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993040" y="1737000"/>
                <a:ext cx="8100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-DHFR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3005280" y="2238840"/>
                <a:ext cx="1172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-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-Tubulin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rot="19793400">
                <a:off x="1474920" y="1133280"/>
                <a:ext cx="17442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negative control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rot="19971600">
                <a:off x="2319480" y="1365480"/>
                <a:ext cx="9122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SimSun"/>
                  </a:rPr>
                  <a:t>siDHFR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aphicFrame>
            <p:nvGraphicFramePr>
              <p:cNvPr id="62" name=""/>
              <p:cNvGraphicFramePr/>
              <p:nvPr/>
            </p:nvGraphicFramePr>
            <p:xfrm>
              <a:off x="1371600" y="1791000"/>
              <a:ext cx="1600200" cy="304920"/>
            </p:xfrm>
            <a:graphic>
              <a:graphicData uri="http://schemas.openxmlformats.org/presentationml/2006/ole">
                <p:oleObj r:id="rId5" spid="">
                  <p:embed/>
                  <p:pic>
                    <p:nvPicPr>
                      <p:cNvPr id="63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1371600" y="1791000"/>
                        <a:ext cx="1600200" cy="30492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  <p:graphicFrame>
            <p:nvGraphicFramePr>
              <p:cNvPr id="64" name=""/>
              <p:cNvGraphicFramePr/>
              <p:nvPr/>
            </p:nvGraphicFramePr>
            <p:xfrm>
              <a:off x="1371600" y="2248200"/>
              <a:ext cx="1600200" cy="290520"/>
            </p:xfrm>
            <a:graphic>
              <a:graphicData uri="http://schemas.openxmlformats.org/presentationml/2006/ole">
                <p:oleObj r:id="rId7" spid="">
                  <p:embed/>
                  <p:pic>
                    <p:nvPicPr>
                      <p:cNvPr id="65" name="" descr=""/>
                      <p:cNvPicPr/>
                      <p:nvPr/>
                    </p:nvPicPr>
                    <p:blipFill>
                      <a:blip r:embed="rId8"/>
                      <a:stretch/>
                    </p:blipFill>
                    <p:spPr>
                      <a:xfrm>
                        <a:off x="1371600" y="2248200"/>
                        <a:ext cx="1600200" cy="290520"/>
                      </a:xfrm>
                      <a:prstGeom prst="rect">
                        <a:avLst/>
                      </a:prstGeom>
                      <a:ln w="6480">
                        <a:solidFill>
                          <a:srgbClr val="000000"/>
                        </a:solidFill>
                        <a:miter/>
                      </a:ln>
                    </p:spPr>
                  </p:pic>
                </p:oleObj>
              </a:graphicData>
            </a:graphic>
          </p:graphicFrame>
        </p:grpSp>
      </p:grpSp>
      <p:grpSp>
        <p:nvGrpSpPr>
          <p:cNvPr id="66" name=""/>
          <p:cNvGrpSpPr/>
          <p:nvPr/>
        </p:nvGrpSpPr>
        <p:grpSpPr>
          <a:xfrm>
            <a:off x="436680" y="3114720"/>
            <a:ext cx="8362440" cy="3202920"/>
            <a:chOff x="436680" y="3114720"/>
            <a:chExt cx="8362440" cy="3202920"/>
          </a:xfrm>
        </p:grpSpPr>
        <p:grpSp>
          <p:nvGrpSpPr>
            <p:cNvPr id="67" name=""/>
            <p:cNvGrpSpPr/>
            <p:nvPr/>
          </p:nvGrpSpPr>
          <p:grpSpPr>
            <a:xfrm>
              <a:off x="436680" y="3114720"/>
              <a:ext cx="4308480" cy="3202920"/>
              <a:chOff x="436680" y="3114720"/>
              <a:chExt cx="4308480" cy="3202920"/>
            </a:xfrm>
          </p:grpSpPr>
          <p:sp>
            <p:nvSpPr>
              <p:cNvPr id="68" name=""/>
              <p:cNvSpPr/>
              <p:nvPr/>
            </p:nvSpPr>
            <p:spPr>
              <a:xfrm>
                <a:off x="436680" y="3114720"/>
                <a:ext cx="4308480" cy="3202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1042920" y="3433680"/>
                <a:ext cx="3427560" cy="1993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042920" y="3433680"/>
                <a:ext cx="42840" cy="1993680"/>
              </a:xfrm>
              <a:custGeom>
                <a:avLst/>
                <a:gdLst/>
                <a:ahLst/>
                <a:rect l="l" t="t" r="r" b="b"/>
                <a:pathLst>
                  <a:path w="4" h="150">
                    <a:moveTo>
                      <a:pt x="0" y="0"/>
                    </a:moveTo>
                    <a:lnTo>
                      <a:pt x="0" y="150"/>
                    </a:lnTo>
                    <a:lnTo>
                      <a:pt x="4" y="150"/>
                    </a:lnTo>
                  </a:path>
                </a:pathLst>
              </a:custGeom>
              <a:noFill/>
              <a:ln w="223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1042920" y="4935240"/>
                <a:ext cx="4284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042920" y="4430520"/>
                <a:ext cx="4284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042920" y="3938400"/>
                <a:ext cx="4284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1042920" y="3433680"/>
                <a:ext cx="4284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042920" y="5427720"/>
                <a:ext cx="3427560" cy="0"/>
              </a:xfrm>
              <a:prstGeom prst="line">
                <a:avLst/>
              </a:prstGeom>
              <a:ln w="22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1384200" y="3646440"/>
                <a:ext cx="2743200" cy="1659960"/>
              </a:xfrm>
              <a:custGeom>
                <a:avLst/>
                <a:gdLst/>
                <a:ahLst/>
                <a:rect l="l" t="t" r="r" b="b"/>
                <a:pathLst>
                  <a:path w="249" h="125">
                    <a:moveTo>
                      <a:pt x="0" y="125"/>
                    </a:moveTo>
                    <a:lnTo>
                      <a:pt x="62" y="117"/>
                    </a:lnTo>
                    <a:lnTo>
                      <a:pt x="125" y="89"/>
                    </a:lnTo>
                    <a:lnTo>
                      <a:pt x="187" y="43"/>
                    </a:lnTo>
                    <a:lnTo>
                      <a:pt x="249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V="1">
                <a:off x="1384200" y="5294160"/>
                <a:ext cx="0" cy="1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351080" y="52941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V="1">
                <a:off x="2066760" y="5187960"/>
                <a:ext cx="0" cy="12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033640" y="51879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V="1">
                <a:off x="2762280" y="4789080"/>
                <a:ext cx="0" cy="39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728800" y="47894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V="1">
                <a:off x="3444840" y="4177800"/>
                <a:ext cx="0" cy="39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3411360" y="4178160"/>
                <a:ext cx="781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 flipV="1">
                <a:off x="4127400" y="3631680"/>
                <a:ext cx="0" cy="140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095720" y="36320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384200" y="5306760"/>
                <a:ext cx="0" cy="266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351080" y="53337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066760" y="5200560"/>
                <a:ext cx="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033640" y="52005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762280" y="4829040"/>
                <a:ext cx="0" cy="39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728800" y="48686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3444840" y="4217760"/>
                <a:ext cx="0" cy="39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411360" y="4257720"/>
                <a:ext cx="781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127400" y="3646440"/>
                <a:ext cx="0" cy="248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4095720" y="36716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384200" y="3725640"/>
                <a:ext cx="2743200" cy="1595160"/>
              </a:xfrm>
              <a:custGeom>
                <a:avLst/>
                <a:gdLst/>
                <a:ahLst/>
                <a:rect l="l" t="t" r="r" b="b"/>
                <a:pathLst>
                  <a:path w="249" h="120">
                    <a:moveTo>
                      <a:pt x="0" y="120"/>
                    </a:moveTo>
                    <a:lnTo>
                      <a:pt x="62" y="110"/>
                    </a:lnTo>
                    <a:lnTo>
                      <a:pt x="125" y="75"/>
                    </a:lnTo>
                    <a:lnTo>
                      <a:pt x="187" y="42"/>
                    </a:lnTo>
                    <a:lnTo>
                      <a:pt x="249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1384200" y="5306400"/>
                <a:ext cx="0" cy="140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351080" y="53067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2066760" y="5174640"/>
                <a:ext cx="0" cy="12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033640" y="517500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2762280" y="4709520"/>
                <a:ext cx="0" cy="12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728800" y="470988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 flipV="1">
                <a:off x="3444840" y="4243320"/>
                <a:ext cx="0" cy="410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411360" y="4243320"/>
                <a:ext cx="781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4127400" y="3631680"/>
                <a:ext cx="0" cy="93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4095720" y="36320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1384200" y="5321160"/>
                <a:ext cx="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1351080" y="53211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066760" y="5187960"/>
                <a:ext cx="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033640" y="5187960"/>
                <a:ext cx="777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762280" y="4722840"/>
                <a:ext cx="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728800" y="47228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444840" y="4284720"/>
                <a:ext cx="0" cy="39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411360" y="4324320"/>
                <a:ext cx="781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4127400" y="3725640"/>
                <a:ext cx="0" cy="932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440" bIns="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4095720" y="3819240"/>
                <a:ext cx="7632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1351080" y="5267160"/>
                <a:ext cx="66600" cy="79200"/>
              </a:xfrm>
              <a:custGeom>
                <a:avLst/>
                <a:gdLst/>
                <a:ahLst/>
                <a:rect l="l" t="t" r="r" b="b"/>
                <a:pathLst>
                  <a:path w="42" h="50">
                    <a:moveTo>
                      <a:pt x="21" y="0"/>
                    </a:moveTo>
                    <a:lnTo>
                      <a:pt x="42" y="25"/>
                    </a:lnTo>
                    <a:lnTo>
                      <a:pt x="21" y="50"/>
                    </a:lnTo>
                    <a:lnTo>
                      <a:pt x="0" y="25"/>
                    </a:lnTo>
                    <a:lnTo>
                      <a:pt x="2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033640" y="5160960"/>
                <a:ext cx="66600" cy="78840"/>
              </a:xfrm>
              <a:custGeom>
                <a:avLst/>
                <a:gdLst/>
                <a:ahLst/>
                <a:rect l="l" t="t" r="r" b="b"/>
                <a:pathLst>
                  <a:path w="42" h="50">
                    <a:moveTo>
                      <a:pt x="21" y="0"/>
                    </a:moveTo>
                    <a:lnTo>
                      <a:pt x="42" y="25"/>
                    </a:lnTo>
                    <a:lnTo>
                      <a:pt x="21" y="50"/>
                    </a:lnTo>
                    <a:lnTo>
                      <a:pt x="0" y="25"/>
                    </a:lnTo>
                    <a:lnTo>
                      <a:pt x="2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728800" y="4789440"/>
                <a:ext cx="65160" cy="78840"/>
              </a:xfrm>
              <a:custGeom>
                <a:avLst/>
                <a:gdLst/>
                <a:ahLst/>
                <a:rect l="l" t="t" r="r" b="b"/>
                <a:pathLst>
                  <a:path w="41" h="50">
                    <a:moveTo>
                      <a:pt x="21" y="0"/>
                    </a:moveTo>
                    <a:lnTo>
                      <a:pt x="41" y="25"/>
                    </a:lnTo>
                    <a:lnTo>
                      <a:pt x="21" y="50"/>
                    </a:lnTo>
                    <a:lnTo>
                      <a:pt x="0" y="25"/>
                    </a:lnTo>
                    <a:lnTo>
                      <a:pt x="2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411360" y="4178160"/>
                <a:ext cx="66960" cy="79200"/>
              </a:xfrm>
              <a:custGeom>
                <a:avLst/>
                <a:gdLst/>
                <a:ahLst/>
                <a:rect l="l" t="t" r="r" b="b"/>
                <a:pathLst>
                  <a:path w="42" h="50">
                    <a:moveTo>
                      <a:pt x="21" y="0"/>
                    </a:moveTo>
                    <a:lnTo>
                      <a:pt x="42" y="25"/>
                    </a:lnTo>
                    <a:lnTo>
                      <a:pt x="21" y="50"/>
                    </a:lnTo>
                    <a:lnTo>
                      <a:pt x="0" y="25"/>
                    </a:lnTo>
                    <a:lnTo>
                      <a:pt x="2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4095720" y="3606840"/>
                <a:ext cx="65160" cy="78840"/>
              </a:xfrm>
              <a:custGeom>
                <a:avLst/>
                <a:gdLst/>
                <a:ahLst/>
                <a:rect l="l" t="t" r="r" b="b"/>
                <a:pathLst>
                  <a:path w="41" h="50">
                    <a:moveTo>
                      <a:pt x="20" y="0"/>
                    </a:moveTo>
                    <a:lnTo>
                      <a:pt x="41" y="25"/>
                    </a:lnTo>
                    <a:lnTo>
                      <a:pt x="20" y="50"/>
                    </a:lnTo>
                    <a:lnTo>
                      <a:pt x="0" y="25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1351080" y="5279760"/>
                <a:ext cx="66600" cy="8064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033640" y="5148000"/>
                <a:ext cx="66600" cy="7920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728800" y="4682880"/>
                <a:ext cx="65160" cy="7920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411360" y="4243320"/>
                <a:ext cx="66960" cy="8064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840" bIns="33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4095720" y="3686040"/>
                <a:ext cx="65160" cy="7920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855000" y="532116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731880" y="482904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731880" y="432432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731880" y="383220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731880" y="332712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1350360" y="557352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032920" y="557352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2728440" y="557352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411000" y="557352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4095000" y="557352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2584080" y="5878440"/>
                <a:ext cx="425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(day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 rot="16200000">
                <a:off x="-335520" y="4325400"/>
                <a:ext cx="1866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Cell Proliferation (OD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1197000" y="3313080"/>
                <a:ext cx="1542960" cy="704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241280" y="3500280"/>
                <a:ext cx="2970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351080" y="3460680"/>
                <a:ext cx="66600" cy="78840"/>
              </a:xfrm>
              <a:custGeom>
                <a:avLst/>
                <a:gdLst/>
                <a:ahLst/>
                <a:rect l="l" t="t" r="r" b="b"/>
                <a:pathLst>
                  <a:path w="42" h="50">
                    <a:moveTo>
                      <a:pt x="21" y="0"/>
                    </a:moveTo>
                    <a:lnTo>
                      <a:pt x="42" y="25"/>
                    </a:lnTo>
                    <a:lnTo>
                      <a:pt x="21" y="50"/>
                    </a:lnTo>
                    <a:lnTo>
                      <a:pt x="0" y="25"/>
                    </a:lnTo>
                    <a:lnTo>
                      <a:pt x="21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566720" y="3379680"/>
                <a:ext cx="13770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negative contro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241280" y="3844800"/>
                <a:ext cx="2970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351080" y="3805200"/>
                <a:ext cx="66600" cy="7884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571400" y="3725640"/>
                <a:ext cx="642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siDHFR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7" name=""/>
            <p:cNvGrpSpPr/>
            <p:nvPr/>
          </p:nvGrpSpPr>
          <p:grpSpPr>
            <a:xfrm>
              <a:off x="4762440" y="3425760"/>
              <a:ext cx="4036680" cy="2600640"/>
              <a:chOff x="4762440" y="3425760"/>
              <a:chExt cx="4036680" cy="2600640"/>
            </a:xfrm>
          </p:grpSpPr>
          <p:sp>
            <p:nvSpPr>
              <p:cNvPr id="148" name=""/>
              <p:cNvSpPr/>
              <p:nvPr/>
            </p:nvSpPr>
            <p:spPr>
              <a:xfrm>
                <a:off x="5332320" y="3519720"/>
                <a:ext cx="44280" cy="1900080"/>
              </a:xfrm>
              <a:custGeom>
                <a:avLst/>
                <a:gdLst/>
                <a:ahLst/>
                <a:rect l="l" t="t" r="r" b="b"/>
                <a:pathLst>
                  <a:path w="4" h="160">
                    <a:moveTo>
                      <a:pt x="0" y="0"/>
                    </a:moveTo>
                    <a:lnTo>
                      <a:pt x="0" y="160"/>
                    </a:lnTo>
                    <a:lnTo>
                      <a:pt x="4" y="160"/>
                    </a:lnTo>
                  </a:path>
                </a:pathLst>
              </a:custGeom>
              <a:noFill/>
              <a:ln w="205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5332320" y="5100480"/>
                <a:ext cx="4428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5332320" y="4790520"/>
                <a:ext cx="4428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5332320" y="4470840"/>
                <a:ext cx="4428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5332320" y="4149360"/>
                <a:ext cx="4428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5332320" y="3841200"/>
                <a:ext cx="4428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332320" y="3519720"/>
                <a:ext cx="4428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5332320" y="5420160"/>
                <a:ext cx="346680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5682240" y="4019400"/>
                <a:ext cx="2766600" cy="1317600"/>
              </a:xfrm>
              <a:custGeom>
                <a:avLst/>
                <a:gdLst/>
                <a:ahLst/>
                <a:rect l="l" t="t" r="r" b="b"/>
                <a:pathLst>
                  <a:path w="253" h="111">
                    <a:moveTo>
                      <a:pt x="0" y="111"/>
                    </a:moveTo>
                    <a:lnTo>
                      <a:pt x="63" y="104"/>
                    </a:lnTo>
                    <a:lnTo>
                      <a:pt x="127" y="86"/>
                    </a:lnTo>
                    <a:lnTo>
                      <a:pt x="190" y="52"/>
                    </a:lnTo>
                    <a:lnTo>
                      <a:pt x="253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 flipV="1">
                <a:off x="5682240" y="532548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5649120" y="532584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 flipV="1">
                <a:off x="6370920" y="524268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6338160" y="5243040"/>
                <a:ext cx="774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V="1">
                <a:off x="7071480" y="502848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7038360" y="502884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 flipV="1">
                <a:off x="7760160" y="462456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7727400" y="4624920"/>
                <a:ext cx="756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 flipV="1">
                <a:off x="8449200" y="3959640"/>
                <a:ext cx="0" cy="597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8415720" y="395964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5682240" y="533736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5649120" y="534888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6370920" y="5254560"/>
                <a:ext cx="0" cy="226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6338160" y="5277240"/>
                <a:ext cx="774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7071480" y="504036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7038360" y="505188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7760160" y="4636440"/>
                <a:ext cx="0" cy="12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7727400" y="4649040"/>
                <a:ext cx="756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8449200" y="4019400"/>
                <a:ext cx="0" cy="583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8415720" y="407808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5682240" y="3638160"/>
                <a:ext cx="2766600" cy="1687320"/>
              </a:xfrm>
              <a:custGeom>
                <a:avLst/>
                <a:gdLst/>
                <a:ahLst/>
                <a:rect l="l" t="t" r="r" b="b"/>
                <a:pathLst>
                  <a:path w="253" h="142">
                    <a:moveTo>
                      <a:pt x="0" y="142"/>
                    </a:moveTo>
                    <a:lnTo>
                      <a:pt x="63" y="132"/>
                    </a:lnTo>
                    <a:lnTo>
                      <a:pt x="127" y="102"/>
                    </a:lnTo>
                    <a:lnTo>
                      <a:pt x="190" y="68"/>
                    </a:lnTo>
                    <a:lnTo>
                      <a:pt x="253" y="0"/>
                    </a:lnTo>
                  </a:path>
                </a:pathLst>
              </a:custGeom>
              <a:noFill/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flipV="1">
                <a:off x="5682240" y="5312520"/>
                <a:ext cx="0" cy="1260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649120" y="531288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6370920" y="5207400"/>
                <a:ext cx="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6338160" y="5207400"/>
                <a:ext cx="774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V="1">
                <a:off x="7071480" y="483876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7038360" y="483912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 flipV="1">
                <a:off x="7760160" y="4423320"/>
                <a:ext cx="0" cy="226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7727400" y="4423680"/>
                <a:ext cx="756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 flipV="1">
                <a:off x="8449200" y="3568320"/>
                <a:ext cx="0" cy="698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8415720" y="3568320"/>
                <a:ext cx="7596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682240" y="5325840"/>
                <a:ext cx="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6370920" y="5207400"/>
                <a:ext cx="0" cy="1116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7071480" y="4850640"/>
                <a:ext cx="0" cy="2412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7760160" y="4446360"/>
                <a:ext cx="0" cy="3564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160" bIns="-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8449200" y="3638160"/>
                <a:ext cx="0" cy="7128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5649120" y="5301720"/>
                <a:ext cx="66240" cy="71280"/>
              </a:xfrm>
              <a:custGeom>
                <a:avLst/>
                <a:gdLst/>
                <a:ahLst/>
                <a:rect l="l" t="t" r="r" b="b"/>
                <a:pathLst>
                  <a:path w="40" h="44">
                    <a:moveTo>
                      <a:pt x="20" y="0"/>
                    </a:moveTo>
                    <a:lnTo>
                      <a:pt x="40" y="22"/>
                    </a:lnTo>
                    <a:lnTo>
                      <a:pt x="20" y="44"/>
                    </a:lnTo>
                    <a:lnTo>
                      <a:pt x="0" y="22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6338160" y="5218920"/>
                <a:ext cx="65880" cy="71280"/>
              </a:xfrm>
              <a:custGeom>
                <a:avLst/>
                <a:gdLst/>
                <a:ahLst/>
                <a:rect l="l" t="t" r="r" b="b"/>
                <a:pathLst>
                  <a:path w="40" h="44">
                    <a:moveTo>
                      <a:pt x="20" y="0"/>
                    </a:moveTo>
                    <a:lnTo>
                      <a:pt x="40" y="22"/>
                    </a:lnTo>
                    <a:lnTo>
                      <a:pt x="20" y="44"/>
                    </a:lnTo>
                    <a:lnTo>
                      <a:pt x="0" y="22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7038360" y="5004720"/>
                <a:ext cx="65880" cy="71280"/>
              </a:xfrm>
              <a:custGeom>
                <a:avLst/>
                <a:gdLst/>
                <a:ahLst/>
                <a:rect l="l" t="t" r="r" b="b"/>
                <a:pathLst>
                  <a:path w="40" h="44">
                    <a:moveTo>
                      <a:pt x="20" y="0"/>
                    </a:moveTo>
                    <a:lnTo>
                      <a:pt x="40" y="22"/>
                    </a:lnTo>
                    <a:lnTo>
                      <a:pt x="20" y="44"/>
                    </a:lnTo>
                    <a:lnTo>
                      <a:pt x="0" y="22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7727400" y="4600440"/>
                <a:ext cx="65880" cy="71280"/>
              </a:xfrm>
              <a:custGeom>
                <a:avLst/>
                <a:gdLst/>
                <a:ahLst/>
                <a:rect l="l" t="t" r="r" b="b"/>
                <a:pathLst>
                  <a:path w="40" h="44">
                    <a:moveTo>
                      <a:pt x="20" y="0"/>
                    </a:moveTo>
                    <a:lnTo>
                      <a:pt x="40" y="22"/>
                    </a:lnTo>
                    <a:lnTo>
                      <a:pt x="20" y="44"/>
                    </a:lnTo>
                    <a:lnTo>
                      <a:pt x="0" y="22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8415720" y="3983760"/>
                <a:ext cx="66240" cy="71280"/>
              </a:xfrm>
              <a:custGeom>
                <a:avLst/>
                <a:gdLst/>
                <a:ahLst/>
                <a:rect l="l" t="t" r="r" b="b"/>
                <a:pathLst>
                  <a:path w="40" h="44">
                    <a:moveTo>
                      <a:pt x="20" y="0"/>
                    </a:moveTo>
                    <a:lnTo>
                      <a:pt x="40" y="22"/>
                    </a:lnTo>
                    <a:lnTo>
                      <a:pt x="20" y="44"/>
                    </a:lnTo>
                    <a:lnTo>
                      <a:pt x="0" y="22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5649120" y="5290200"/>
                <a:ext cx="66240" cy="7128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6338160" y="5171760"/>
                <a:ext cx="65880" cy="7128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7038360" y="4814640"/>
                <a:ext cx="65880" cy="7128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7727400" y="4410720"/>
                <a:ext cx="65880" cy="7128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8415720" y="3603960"/>
                <a:ext cx="66240" cy="6984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146200" y="532584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5034960" y="500472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034960" y="469620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034960" y="437508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034960" y="405540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146200" y="374544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034960" y="3425760"/>
                <a:ext cx="249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5648760" y="555156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6337800" y="555156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7038000" y="555156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7727040" y="555156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8415360" y="5551560"/>
                <a:ext cx="99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6904800" y="5812920"/>
                <a:ext cx="4258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(day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rot="16200000">
                <a:off x="3935880" y="4290120"/>
                <a:ext cx="18662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Cell Proliferation (OD)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5482440" y="3558960"/>
                <a:ext cx="2952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5592960" y="3522960"/>
                <a:ext cx="64080" cy="71280"/>
              </a:xfrm>
              <a:custGeom>
                <a:avLst/>
                <a:gdLst/>
                <a:ahLst/>
                <a:rect l="l" t="t" r="r" b="b"/>
                <a:pathLst>
                  <a:path w="39" h="44">
                    <a:moveTo>
                      <a:pt x="20" y="0"/>
                    </a:moveTo>
                    <a:lnTo>
                      <a:pt x="39" y="22"/>
                    </a:lnTo>
                    <a:lnTo>
                      <a:pt x="20" y="44"/>
                    </a:lnTo>
                    <a:lnTo>
                      <a:pt x="0" y="22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11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5811120" y="3451680"/>
                <a:ext cx="142200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negative control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482440" y="3891600"/>
                <a:ext cx="295200" cy="0"/>
              </a:xfrm>
              <a:prstGeom prst="line">
                <a:avLst/>
              </a:prstGeom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5592960" y="3855600"/>
                <a:ext cx="64080" cy="71280"/>
              </a:xfrm>
              <a:prstGeom prst="rect">
                <a:avLst/>
              </a:prstGeom>
              <a:solidFill>
                <a:srgbClr val="000000"/>
              </a:solidFill>
              <a:ln w="11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5810040" y="3784320"/>
                <a:ext cx="3772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siT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23" name=""/>
          <p:cNvSpPr/>
          <p:nvPr/>
        </p:nvSpPr>
        <p:spPr>
          <a:xfrm>
            <a:off x="761760" y="2830680"/>
            <a:ext cx="4204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                                          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720240" y="6132600"/>
            <a:ext cx="203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HCT 116 (wt-p5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bo</cp:lastModifiedBy>
  <dcterms:modified xsi:type="dcterms:W3CDTF">2010-04-12T18:33:33Z</dcterms:modified>
  <cp:revision>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